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4563A52B-1097-4976-843B-3D64B143AD1C}" v="7" dt="2024-05-20T16:12:17.60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56" d="100"/>
          <a:sy n="56" d="100"/>
        </p:scale>
        <p:origin x="77" y="3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4563A52B-1097-4976-843B-3D64B143AD1C}"/>
    <pc:docChg chg="custSel delSld modSld">
      <pc:chgData name="Laycock, Joseph" userId="c4bfcbf4-3ccc-440e-b317-559baf184f0d" providerId="ADAL" clId="{4563A52B-1097-4976-843B-3D64B143AD1C}" dt="2024-05-20T16:12:17.601" v="19" actId="1036"/>
      <pc:docMkLst>
        <pc:docMk/>
      </pc:docMkLst>
      <pc:sldChg chg="addSp delSp modSp mod">
        <pc:chgData name="Laycock, Joseph" userId="c4bfcbf4-3ccc-440e-b317-559baf184f0d" providerId="ADAL" clId="{4563A52B-1097-4976-843B-3D64B143AD1C}" dt="2024-05-20T16:12:17.601" v="19" actId="1036"/>
        <pc:sldMkLst>
          <pc:docMk/>
          <pc:sldMk cId="2867428870" sldId="268"/>
        </pc:sldMkLst>
        <pc:spChg chg="del">
          <ac:chgData name="Laycock, Joseph" userId="c4bfcbf4-3ccc-440e-b317-559baf184f0d" providerId="ADAL" clId="{4563A52B-1097-4976-843B-3D64B143AD1C}" dt="2024-05-20T16:12:12.934" v="12" actId="478"/>
          <ac:spMkLst>
            <pc:docMk/>
            <pc:sldMk cId="2867428870" sldId="268"/>
            <ac:spMk id="2" creationId="{F36A2367-4C1F-DF61-526E-3B5E7804B265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3" creationId="{B519394D-926A-B2EB-5B97-F6089DA73AA1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4" creationId="{63326687-F13D-91EE-5338-8E15441244E7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5" creationId="{AE68901C-C368-6A6D-C160-1C8BC20AE4DE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6" creationId="{403A2B69-191B-ADEA-CCB6-0CB0E851D680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7" creationId="{80C43956-E309-0D47-EF17-18E462CDB581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8" creationId="{3B919ECB-A442-0864-480E-C80524BDD6FD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9" creationId="{7E1AE4E8-8DAA-E76B-21B8-982A7ABF7E93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12" creationId="{7C467C67-00C9-781E-839E-36B19D918CAA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13" creationId="{F8E83667-67C7-3290-A51C-6497ED9D5A64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14" creationId="{078E2448-58D2-F103-D575-286827976EE2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15" creationId="{0CD70BD1-F13D-6629-92C4-6CE4FEF4D7CF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16" creationId="{62E15DF7-E3CC-A64E-B4EA-E52ADC43575B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17" creationId="{60168B6E-794E-BB8E-2C4D-EAD11B87C2F9}"/>
          </ac:spMkLst>
        </pc:spChg>
        <pc:spChg chg="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21" creationId="{3488F7A3-3DE8-D52D-1C64-83310FF38A15}"/>
          </ac:spMkLst>
        </pc:spChg>
        <pc:spChg chg="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22" creationId="{2A17529F-94BE-8458-F378-0B9B66955E47}"/>
          </ac:spMkLst>
        </pc:spChg>
        <pc:spChg chg="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23" creationId="{D34ADADA-125A-8016-0AA5-3FD30098B237}"/>
          </ac:spMkLst>
        </pc:spChg>
        <pc:spChg chg="mod">
          <ac:chgData name="Laycock, Joseph" userId="c4bfcbf4-3ccc-440e-b317-559baf184f0d" providerId="ADAL" clId="{4563A52B-1097-4976-843B-3D64B143AD1C}" dt="2024-05-20T16:11:25.672" v="6"/>
          <ac:spMkLst>
            <pc:docMk/>
            <pc:sldMk cId="2867428870" sldId="268"/>
            <ac:spMk id="24" creationId="{00000000-0000-0000-0000-000000000000}"/>
          </ac:spMkLst>
        </pc:spChg>
        <pc:spChg chg="mod">
          <ac:chgData name="Laycock, Joseph" userId="c4bfcbf4-3ccc-440e-b317-559baf184f0d" providerId="ADAL" clId="{4563A52B-1097-4976-843B-3D64B143AD1C}" dt="2024-05-20T16:11:32.829" v="7"/>
          <ac:spMkLst>
            <pc:docMk/>
            <pc:sldMk cId="2867428870" sldId="268"/>
            <ac:spMk id="25" creationId="{00000000-0000-0000-0000-000000000000}"/>
          </ac:spMkLst>
        </pc:spChg>
        <pc:spChg chg="del mod">
          <ac:chgData name="Laycock, Joseph" userId="c4bfcbf4-3ccc-440e-b317-559baf184f0d" providerId="ADAL" clId="{4563A52B-1097-4976-843B-3D64B143AD1C}" dt="2024-05-20T16:12:08.587" v="11" actId="478"/>
          <ac:spMkLst>
            <pc:docMk/>
            <pc:sldMk cId="2867428870" sldId="268"/>
            <ac:spMk id="26" creationId="{00000000-0000-0000-0000-000000000000}"/>
          </ac:spMkLst>
        </pc:spChg>
        <pc:spChg chg="mod">
          <ac:chgData name="Laycock, Joseph" userId="c4bfcbf4-3ccc-440e-b317-559baf184f0d" providerId="ADAL" clId="{4563A52B-1097-4976-843B-3D64B143AD1C}" dt="2024-05-20T16:11:48.498" v="9"/>
          <ac:spMkLst>
            <pc:docMk/>
            <pc:sldMk cId="2867428870" sldId="268"/>
            <ac:spMk id="27" creationId="{00000000-0000-0000-0000-000000000000}"/>
          </ac:spMkLst>
        </pc:spChg>
        <pc:spChg chg="mod">
          <ac:chgData name="Laycock, Joseph" userId="c4bfcbf4-3ccc-440e-b317-559baf184f0d" providerId="ADAL" clId="{4563A52B-1097-4976-843B-3D64B143AD1C}" dt="2024-05-20T16:11:39.476" v="8"/>
          <ac:spMkLst>
            <pc:docMk/>
            <pc:sldMk cId="2867428870" sldId="268"/>
            <ac:spMk id="28" creationId="{00000000-0000-0000-0000-000000000000}"/>
          </ac:spMkLst>
        </pc:spChg>
        <pc:spChg chg="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29" creationId="{239E8A7F-F349-0BA4-6AA6-42FDA3EA0BB0}"/>
          </ac:spMkLst>
        </pc:spChg>
        <pc:spChg chg="add mod">
          <ac:chgData name="Laycock, Joseph" userId="c4bfcbf4-3ccc-440e-b317-559baf184f0d" providerId="ADAL" clId="{4563A52B-1097-4976-843B-3D64B143AD1C}" dt="2024-05-20T16:12:17.601" v="19" actId="1036"/>
          <ac:spMkLst>
            <pc:docMk/>
            <pc:sldMk cId="2867428870" sldId="268"/>
            <ac:spMk id="30" creationId="{2B0421EC-2877-7251-41C3-780E3415D079}"/>
          </ac:spMkLst>
        </pc:spChg>
        <pc:grpChg chg="add mod">
          <ac:chgData name="Laycock, Joseph" userId="c4bfcbf4-3ccc-440e-b317-559baf184f0d" providerId="ADAL" clId="{4563A52B-1097-4976-843B-3D64B143AD1C}" dt="2024-05-20T16:12:17.601" v="19" actId="1036"/>
          <ac:grpSpMkLst>
            <pc:docMk/>
            <pc:sldMk cId="2867428870" sldId="268"/>
            <ac:grpSpMk id="18" creationId="{07CB3703-6BBB-7BBB-D917-B030E4301A0B}"/>
          </ac:grpSpMkLst>
        </pc:grpChg>
        <pc:picChg chg="add mod">
          <ac:chgData name="Laycock, Joseph" userId="c4bfcbf4-3ccc-440e-b317-559baf184f0d" providerId="ADAL" clId="{4563A52B-1097-4976-843B-3D64B143AD1C}" dt="2024-05-20T16:12:17.601" v="19" actId="1036"/>
          <ac:picMkLst>
            <pc:docMk/>
            <pc:sldMk cId="2867428870" sldId="268"/>
            <ac:picMk id="11" creationId="{8C6B54AA-7477-C108-7B73-E21A802CECF7}"/>
          </ac:picMkLst>
        </pc:picChg>
        <pc:picChg chg="mod">
          <ac:chgData name="Laycock, Joseph" userId="c4bfcbf4-3ccc-440e-b317-559baf184f0d" providerId="ADAL" clId="{4563A52B-1097-4976-843B-3D64B143AD1C}" dt="2024-05-20T16:12:17.601" v="19" actId="1036"/>
          <ac:picMkLst>
            <pc:docMk/>
            <pc:sldMk cId="2867428870" sldId="268"/>
            <ac:picMk id="19" creationId="{E033AE1A-D08A-5FB1-2116-D8FB40333890}"/>
          </ac:picMkLst>
        </pc:picChg>
        <pc:picChg chg="mod">
          <ac:chgData name="Laycock, Joseph" userId="c4bfcbf4-3ccc-440e-b317-559baf184f0d" providerId="ADAL" clId="{4563A52B-1097-4976-843B-3D64B143AD1C}" dt="2024-05-20T16:12:17.601" v="19" actId="1036"/>
          <ac:picMkLst>
            <pc:docMk/>
            <pc:sldMk cId="2867428870" sldId="268"/>
            <ac:picMk id="20" creationId="{E7CB788C-6D3F-8024-E1B7-389025A0235D}"/>
          </ac:picMkLst>
        </pc:picChg>
        <pc:cxnChg chg="add mod">
          <ac:chgData name="Laycock, Joseph" userId="c4bfcbf4-3ccc-440e-b317-559baf184f0d" providerId="ADAL" clId="{4563A52B-1097-4976-843B-3D64B143AD1C}" dt="2024-05-20T16:12:17.601" v="19" actId="1036"/>
          <ac:cxnSpMkLst>
            <pc:docMk/>
            <pc:sldMk cId="2867428870" sldId="268"/>
            <ac:cxnSpMk id="10" creationId="{A36EE6BF-A4EE-7E7C-2186-CBAA464FCBB1}"/>
          </ac:cxnSpMkLst>
        </pc:cxnChg>
      </pc:sldChg>
      <pc:sldChg chg="del">
        <pc:chgData name="Laycock, Joseph" userId="c4bfcbf4-3ccc-440e-b317-559baf184f0d" providerId="ADAL" clId="{4563A52B-1097-4976-843B-3D64B143AD1C}" dt="2024-05-20T16:11:17.968" v="5" actId="47"/>
        <pc:sldMkLst>
          <pc:docMk/>
          <pc:sldMk cId="808818969" sldId="269"/>
        </pc:sldMkLst>
      </pc:sldChg>
      <pc:sldChg chg="del">
        <pc:chgData name="Laycock, Joseph" userId="c4bfcbf4-3ccc-440e-b317-559baf184f0d" providerId="ADAL" clId="{4563A52B-1097-4976-843B-3D64B143AD1C}" dt="2024-05-20T16:11:15.827" v="1" actId="47"/>
        <pc:sldMkLst>
          <pc:docMk/>
          <pc:sldMk cId="3242791597" sldId="270"/>
        </pc:sldMkLst>
      </pc:sldChg>
      <pc:sldChg chg="del">
        <pc:chgData name="Laycock, Joseph" userId="c4bfcbf4-3ccc-440e-b317-559baf184f0d" providerId="ADAL" clId="{4563A52B-1097-4976-843B-3D64B143AD1C}" dt="2024-05-20T16:11:15.448" v="0" actId="47"/>
        <pc:sldMkLst>
          <pc:docMk/>
          <pc:sldMk cId="1120905658" sldId="271"/>
        </pc:sldMkLst>
      </pc:sldChg>
      <pc:sldChg chg="del">
        <pc:chgData name="Laycock, Joseph" userId="c4bfcbf4-3ccc-440e-b317-559baf184f0d" providerId="ADAL" clId="{4563A52B-1097-4976-843B-3D64B143AD1C}" dt="2024-05-20T16:11:17.072" v="4" actId="47"/>
        <pc:sldMkLst>
          <pc:docMk/>
          <pc:sldMk cId="4048924459" sldId="272"/>
        </pc:sldMkLst>
      </pc:sldChg>
      <pc:sldChg chg="del">
        <pc:chgData name="Laycock, Joseph" userId="c4bfcbf4-3ccc-440e-b317-559baf184f0d" providerId="ADAL" clId="{4563A52B-1097-4976-843B-3D64B143AD1C}" dt="2024-05-20T16:11:16.524" v="3" actId="47"/>
        <pc:sldMkLst>
          <pc:docMk/>
          <pc:sldMk cId="2977807225" sldId="273"/>
        </pc:sldMkLst>
      </pc:sldChg>
      <pc:sldChg chg="del">
        <pc:chgData name="Laycock, Joseph" userId="c4bfcbf4-3ccc-440e-b317-559baf184f0d" providerId="ADAL" clId="{4563A52B-1097-4976-843B-3D64B143AD1C}" dt="2024-05-20T16:11:16.214" v="2" actId="47"/>
        <pc:sldMkLst>
          <pc:docMk/>
          <pc:sldMk cId="1305034209" sldId="274"/>
        </pc:sldMkLst>
      </pc:sldChg>
      <pc:sldMasterChg chg="delSldLayout">
        <pc:chgData name="Laycock, Joseph" userId="c4bfcbf4-3ccc-440e-b317-559baf184f0d" providerId="ADAL" clId="{4563A52B-1097-4976-843B-3D64B143AD1C}" dt="2024-05-20T16:11:17.968" v="5" actId="47"/>
        <pc:sldMasterMkLst>
          <pc:docMk/>
          <pc:sldMasterMk cId="690031264" sldId="2147483648"/>
        </pc:sldMasterMkLst>
        <pc:sldLayoutChg chg="del">
          <pc:chgData name="Laycock, Joseph" userId="c4bfcbf4-3ccc-440e-b317-559baf184f0d" providerId="ADAL" clId="{4563A52B-1097-4976-843B-3D64B143AD1C}" dt="2024-05-20T16:11:17.968" v="5" actId="47"/>
          <pc:sldLayoutMkLst>
            <pc:docMk/>
            <pc:sldMasterMk cId="690031264" sldId="2147483648"/>
            <pc:sldLayoutMk cId="2266668884" sldId="2147483651"/>
          </pc:sldLayoutMkLst>
        </pc:sldLayoutChg>
      </pc:sldMaster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5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The extent of kidney involvement in paediatric tuberous </a:t>
            </a:r>
          </a:p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sclerosis complex cases: a tertiary hospital analysis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05362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HYPOTHESIS</a:t>
            </a:r>
            <a:r>
              <a:rPr lang="en-GB" dirty="0">
                <a:solidFill>
                  <a:schemeClr val="bg1"/>
                </a:solidFill>
              </a:rPr>
              <a:t>: Children with TSC exhibit kidney lesions and can develop complications similar to adults.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Limavady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hile TSC kidney disease emerges later in the disease course, our findings emphasise the importance of kidney surveillance, including routine kidney imaging, kidney function and blood pressure monitoring. 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519394D-926A-B2EB-5B97-F6089DA73AA1}"/>
              </a:ext>
            </a:extLst>
          </p:cNvPr>
          <p:cNvSpPr txBox="1"/>
          <p:nvPr/>
        </p:nvSpPr>
        <p:spPr>
          <a:xfrm>
            <a:off x="228040" y="1786247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63326687-F13D-91EE-5338-8E15441244E7}"/>
              </a:ext>
            </a:extLst>
          </p:cNvPr>
          <p:cNvSpPr/>
          <p:nvPr/>
        </p:nvSpPr>
        <p:spPr>
          <a:xfrm>
            <a:off x="694682" y="306550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AE68901C-C368-6A6D-C160-1C8BC20AE4DE}"/>
              </a:ext>
            </a:extLst>
          </p:cNvPr>
          <p:cNvSpPr/>
          <p:nvPr/>
        </p:nvSpPr>
        <p:spPr>
          <a:xfrm>
            <a:off x="1030093" y="306550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6" name="Freeform: Shape 46">
            <a:extLst>
              <a:ext uri="{FF2B5EF4-FFF2-40B4-BE49-F238E27FC236}">
                <a16:creationId xmlns:a16="http://schemas.microsoft.com/office/drawing/2014/main" id="{403A2B69-191B-ADEA-CCB6-0CB0E851D680}"/>
              </a:ext>
            </a:extLst>
          </p:cNvPr>
          <p:cNvSpPr/>
          <p:nvPr/>
        </p:nvSpPr>
        <p:spPr>
          <a:xfrm>
            <a:off x="1197799" y="3287045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80C43956-E309-0D47-EF17-18E462CDB581}"/>
              </a:ext>
            </a:extLst>
          </p:cNvPr>
          <p:cNvSpPr/>
          <p:nvPr/>
        </p:nvSpPr>
        <p:spPr>
          <a:xfrm>
            <a:off x="854483" y="3301026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3B919ECB-A442-0864-480E-C80524BDD6FD}"/>
              </a:ext>
            </a:extLst>
          </p:cNvPr>
          <p:cNvSpPr txBox="1"/>
          <p:nvPr/>
        </p:nvSpPr>
        <p:spPr>
          <a:xfrm>
            <a:off x="272364" y="2379911"/>
            <a:ext cx="172838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solidFill>
                  <a:srgbClr val="00437A"/>
                </a:solidFill>
              </a:rPr>
              <a:t>182 children </a:t>
            </a:r>
          </a:p>
          <a:p>
            <a:pPr algn="ctr"/>
            <a:r>
              <a:rPr lang="en-GB" b="1" dirty="0">
                <a:solidFill>
                  <a:srgbClr val="00437A"/>
                </a:solidFill>
              </a:rPr>
              <a:t>with TS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E1AE4E8-8DAA-E76B-21B8-982A7ABF7E93}"/>
              </a:ext>
            </a:extLst>
          </p:cNvPr>
          <p:cNvSpPr txBox="1"/>
          <p:nvPr/>
        </p:nvSpPr>
        <p:spPr>
          <a:xfrm>
            <a:off x="179892" y="4364905"/>
            <a:ext cx="221368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Retrospective</a:t>
            </a:r>
          </a:p>
          <a:p>
            <a:pPr algn="ctr"/>
            <a:r>
              <a:rPr lang="en-GB" dirty="0">
                <a:solidFill>
                  <a:srgbClr val="296DC0"/>
                </a:solidFill>
              </a:rPr>
              <a:t>single centre study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A36EE6BF-A4EE-7E7C-2186-CBAA464FCBB1}"/>
              </a:ext>
            </a:extLst>
          </p:cNvPr>
          <p:cNvCxnSpPr>
            <a:cxnSpLocks/>
          </p:cNvCxnSpPr>
          <p:nvPr/>
        </p:nvCxnSpPr>
        <p:spPr>
          <a:xfrm>
            <a:off x="1828862" y="3737655"/>
            <a:ext cx="800731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2" descr="Kidneys - Free medical icons">
            <a:extLst>
              <a:ext uri="{FF2B5EF4-FFF2-40B4-BE49-F238E27FC236}">
                <a16:creationId xmlns:a16="http://schemas.microsoft.com/office/drawing/2014/main" id="{8C6B54AA-7477-C108-7B73-E21A802CEC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90790" y="3360253"/>
            <a:ext cx="800731" cy="80073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7C467C67-00C9-781E-839E-36B19D918CAA}"/>
              </a:ext>
            </a:extLst>
          </p:cNvPr>
          <p:cNvSpPr/>
          <p:nvPr/>
        </p:nvSpPr>
        <p:spPr>
          <a:xfrm>
            <a:off x="2726962" y="4920500"/>
            <a:ext cx="1751349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AMLs:</a:t>
            </a:r>
          </a:p>
          <a:p>
            <a:pPr algn="ctr"/>
            <a:r>
              <a:rPr lang="en-GB" sz="1600" dirty="0"/>
              <a:t>88/145 (60.9%)</a:t>
            </a: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F8E83667-67C7-3290-A51C-6497ED9D5A64}"/>
              </a:ext>
            </a:extLst>
          </p:cNvPr>
          <p:cNvSpPr/>
          <p:nvPr/>
        </p:nvSpPr>
        <p:spPr>
          <a:xfrm>
            <a:off x="2742998" y="4206650"/>
            <a:ext cx="1735313" cy="622841"/>
          </a:xfrm>
          <a:prstGeom prst="rect">
            <a:avLst/>
          </a:prstGeom>
          <a:solidFill>
            <a:srgbClr val="00385E"/>
          </a:solidFill>
          <a:ln w="41275">
            <a:solidFill>
              <a:srgbClr val="00385E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600" dirty="0"/>
              <a:t>Cysts: </a:t>
            </a:r>
          </a:p>
          <a:p>
            <a:pPr algn="ctr"/>
            <a:r>
              <a:rPr lang="en-GB" sz="1600" dirty="0"/>
              <a:t>78/145 (53.8%)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78E2448-58D2-F103-D575-286827976EE2}"/>
              </a:ext>
            </a:extLst>
          </p:cNvPr>
          <p:cNvSpPr txBox="1"/>
          <p:nvPr/>
        </p:nvSpPr>
        <p:spPr>
          <a:xfrm>
            <a:off x="5440911" y="4479954"/>
            <a:ext cx="3192457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Hyperfiltration: 48.1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Nephromegaly: 32.9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Hypertension: 24.8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Chronic kidney disease: 12.3%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0CD70BD1-F13D-6629-92C4-6CE4FEF4D7CF}"/>
              </a:ext>
            </a:extLst>
          </p:cNvPr>
          <p:cNvSpPr txBox="1"/>
          <p:nvPr/>
        </p:nvSpPr>
        <p:spPr>
          <a:xfrm>
            <a:off x="8633368" y="4492660"/>
            <a:ext cx="2799926" cy="107721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Kidney AMLs &gt; 3 cm: 9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On antihypertensives: 7.2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On everolimus: 7.1%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GB" sz="1600" dirty="0">
                <a:solidFill>
                  <a:srgbClr val="AA0065"/>
                </a:solidFill>
              </a:rPr>
              <a:t>Kidney interventions: 1.6%</a:t>
            </a: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62E15DF7-E3CC-A64E-B4EA-E52ADC43575B}"/>
              </a:ext>
            </a:extLst>
          </p:cNvPr>
          <p:cNvSpPr/>
          <p:nvPr/>
        </p:nvSpPr>
        <p:spPr>
          <a:xfrm>
            <a:off x="5170289" y="4245224"/>
            <a:ext cx="6563685" cy="1289500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>
              <a:solidFill>
                <a:srgbClr val="AA0065"/>
              </a:solidFill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0168B6E-794E-BB8E-2C4D-EAD11B87C2F9}"/>
              </a:ext>
            </a:extLst>
          </p:cNvPr>
          <p:cNvSpPr txBox="1"/>
          <p:nvPr/>
        </p:nvSpPr>
        <p:spPr>
          <a:xfrm>
            <a:off x="6775839" y="4216708"/>
            <a:ext cx="335258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600" b="1" dirty="0">
                <a:solidFill>
                  <a:srgbClr val="AA0065"/>
                </a:solidFill>
              </a:rPr>
              <a:t>Kidney progression and management</a:t>
            </a:r>
            <a:endParaRPr lang="en-US" sz="1600" b="1" dirty="0"/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07CB3703-6BBB-7BBB-D917-B030E4301A0B}"/>
              </a:ext>
            </a:extLst>
          </p:cNvPr>
          <p:cNvGrpSpPr/>
          <p:nvPr/>
        </p:nvGrpSpPr>
        <p:grpSpPr>
          <a:xfrm>
            <a:off x="4365448" y="1742614"/>
            <a:ext cx="7752853" cy="2437789"/>
            <a:chOff x="4310856" y="1715318"/>
            <a:chExt cx="7752853" cy="2437789"/>
          </a:xfrm>
        </p:grpSpPr>
        <p:pic>
          <p:nvPicPr>
            <p:cNvPr id="19" name="Picture 18" descr="A graph with numbers and a line&#10;&#10;Description automatically generated">
              <a:extLst>
                <a:ext uri="{FF2B5EF4-FFF2-40B4-BE49-F238E27FC236}">
                  <a16:creationId xmlns:a16="http://schemas.microsoft.com/office/drawing/2014/main" id="{E033AE1A-D08A-5FB1-2116-D8FB403338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17298"/>
            <a:stretch/>
          </p:blipFill>
          <p:spPr>
            <a:xfrm>
              <a:off x="4310856" y="1741106"/>
              <a:ext cx="4512478" cy="2346999"/>
            </a:xfrm>
            <a:prstGeom prst="rect">
              <a:avLst/>
            </a:prstGeom>
          </p:spPr>
        </p:pic>
        <p:pic>
          <p:nvPicPr>
            <p:cNvPr id="20" name="Picture 19" descr="A graph with numbers and a line&#10;&#10;Description automatically generated">
              <a:extLst>
                <a:ext uri="{FF2B5EF4-FFF2-40B4-BE49-F238E27FC236}">
                  <a16:creationId xmlns:a16="http://schemas.microsoft.com/office/drawing/2014/main" id="{E7CB788C-6D3F-8024-E1B7-389025A0235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13957" t="-1" r="-651" b="16917"/>
            <a:stretch/>
          </p:blipFill>
          <p:spPr>
            <a:xfrm>
              <a:off x="8740662" y="1715318"/>
              <a:ext cx="3132000" cy="2412000"/>
            </a:xfrm>
            <a:prstGeom prst="rect">
              <a:avLst/>
            </a:prstGeom>
          </p:spPr>
        </p:pic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3488F7A3-3DE8-D52D-1C64-83310FF38A15}"/>
                </a:ext>
              </a:extLst>
            </p:cNvPr>
            <p:cNvSpPr txBox="1"/>
            <p:nvPr/>
          </p:nvSpPr>
          <p:spPr>
            <a:xfrm>
              <a:off x="7147969" y="1833104"/>
              <a:ext cx="12132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Kidney cysts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2A17529F-94BE-8458-F378-0B9B66955E47}"/>
                </a:ext>
              </a:extLst>
            </p:cNvPr>
            <p:cNvSpPr txBox="1"/>
            <p:nvPr/>
          </p:nvSpPr>
          <p:spPr>
            <a:xfrm>
              <a:off x="10850456" y="1859981"/>
              <a:ext cx="121325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200" dirty="0">
                  <a:latin typeface="Arial" panose="020B0604020202020204" pitchFamily="34" charset="0"/>
                  <a:cs typeface="Arial" panose="020B0604020202020204" pitchFamily="34" charset="0"/>
                </a:rPr>
                <a:t>Kidney AMLs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id="{D34ADADA-125A-8016-0AA5-3FD30098B237}"/>
                </a:ext>
              </a:extLst>
            </p:cNvPr>
            <p:cNvSpPr/>
            <p:nvPr/>
          </p:nvSpPr>
          <p:spPr>
            <a:xfrm>
              <a:off x="4423719" y="3757588"/>
              <a:ext cx="855803" cy="36933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bg1"/>
                </a:solidFill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id="{239E8A7F-F349-0BA4-6AA6-42FDA3EA0BB0}"/>
                </a:ext>
              </a:extLst>
            </p:cNvPr>
            <p:cNvSpPr/>
            <p:nvPr/>
          </p:nvSpPr>
          <p:spPr>
            <a:xfrm>
              <a:off x="8255073" y="3835696"/>
              <a:ext cx="751604" cy="31741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>
                <a:solidFill>
                  <a:schemeClr val="bg1"/>
                </a:solidFill>
              </a:endParaRP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2B0421EC-2877-7251-41C3-780E3415D079}"/>
              </a:ext>
            </a:extLst>
          </p:cNvPr>
          <p:cNvSpPr txBox="1"/>
          <p:nvPr/>
        </p:nvSpPr>
        <p:spPr>
          <a:xfrm>
            <a:off x="2410244" y="2491637"/>
            <a:ext cx="247759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600" dirty="0">
                <a:solidFill>
                  <a:srgbClr val="00437A"/>
                </a:solidFill>
              </a:rPr>
              <a:t>114 of 145 (78.6%) children with kidney imaging data had kidney lesions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55</TotalTime>
  <Words>158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0</cp:revision>
  <dcterms:created xsi:type="dcterms:W3CDTF">2019-06-13T12:30:18Z</dcterms:created>
  <dcterms:modified xsi:type="dcterms:W3CDTF">2024-05-20T16:12:25Z</dcterms:modified>
</cp:coreProperties>
</file>